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0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30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A4DE32-2249-F4BC-4AF4-1E09E39DC4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698B2A-85CB-751D-EC9A-2B5710C024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583A23-BB84-92A5-4EBC-6BEBE7714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33B6F6-5144-A932-7D46-D1CBDAC8A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91DDE0-EF6A-0FD8-8AB2-6458D53F6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60602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D67AE-7415-1B9D-2A05-EAA2519511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37604F-7DA5-83CB-C1A6-F8DFBD4770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80FCA2-B22F-9649-6E60-67C5F9CCB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202845-6258-4D79-368C-0860BD692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34A138-4323-9720-E562-347DFF8EA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17705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8B57B6-7500-0B0D-C762-6DE1B60A38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8B16E1-31CD-9093-F462-D089CB506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005E87-3692-1D2B-9B9C-0297CBE97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0E7A6C-C4FA-5EFD-D04A-82B398B4D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5F552-D6F5-9CBE-62D1-A7AC6313C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376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BB73DA-FCA0-3001-ADDF-3FFB9715D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C47425-679B-FA37-65F4-0035058FC8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863304-A39F-1278-BB27-EA392D53E0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00B841-A3AB-1212-1580-C44529127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6AB7B-2F2B-F8D8-90CD-7EF2CF188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79941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21E0E-8477-EAC9-28B8-68667F9132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A8ECF3-2D6E-8AEE-9546-35DC1ABD4E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A97C2-2E92-C52F-A35D-083373969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F965CB-F4D6-30E6-F44F-7994D688F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AFA0E7-B089-132F-51C6-D64D42516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4357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673A8-90DB-D474-A2FC-35BCD62148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665C84-5DDA-84EA-D306-906695ABE2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BBC811-E223-DC47-6DC3-3F5BB228FD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D9F60C-7085-88A0-5BBE-39C41E8A8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0DF903-7E55-381E-61E2-B5A6B2959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04365E-7216-2BBA-E08B-45C21DC54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7914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D7ADCD-0AF1-37DD-7A0A-B8094874E4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6998B8-D63B-4CFD-22A1-7ABF5AB120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D4F4A1-90D5-C2FE-64E1-136E45FF54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4DED03-4552-8C8A-0467-E0A222DE1A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FF22F3-755C-84DF-0B47-ECA314EB35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B839E9-3539-82AD-9753-B0FC722AD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5EF096-0371-3805-A6C1-D55FB6119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745335-291E-119F-A479-A7A40D8E1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06343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09E9E-91D9-232F-BD78-C9E57FE0E9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F23261-F021-C5BC-6417-AB0588E10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106460-16DF-2D9F-4783-7963622F9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229E50-715A-5859-4AF4-492B31CA9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8638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E859F93-4E1E-6131-B85E-CD7B4BCDE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98FB60-1957-0476-3311-C3AAD26DA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3A5EDE-CD70-62E0-86E5-D45A8840D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7584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6D4F08-0CCC-A9D1-DA9A-00A431E910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8140C3-C38D-E007-85E2-68EC3C86CA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894749-B893-CAA1-AD9C-C844B0EE04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CCAFED-42F4-AC91-156E-C176132D3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29ECCE-79D5-464B-7826-DE4820B2E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13B05D-C68F-4F4B-C64D-00E5394E4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83932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E5EDD-2C7D-29B1-F89C-06FECE423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D46EEC-8962-A1ED-4D11-CF04F5A42C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113F29-ACAD-598E-B98E-E5484E39BA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A656D4-0DB6-FEA6-6571-45992BF6B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160C38-AA49-427B-886F-BF1D1DF0D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185F80-D824-162B-C506-DE974F248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1894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83335F-DBD5-4B09-7B22-348A3B3F48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6EA64C-CBE1-5F50-2599-AA8E9D8648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7924D5-AACD-08D4-10C6-3D60B5CE75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7F062-010F-41AB-B1EE-D2ADAD5CD547}" type="datetimeFigureOut">
              <a:rPr lang="en-CA" smtClean="0"/>
              <a:t>2024-02-2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44E288-121A-B476-0B23-2619389EF2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601C52-142B-E463-6DDF-555B8D1492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6D4EC-9986-4335-9A6F-B82437BBF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6159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C689303-9993-74A9-24B8-AC46BBB930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3260" y="2586633"/>
            <a:ext cx="8305479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</a:t>
            </a:r>
            <a:r>
              <a:rPr lang="en-CA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en-CA" dirty="0"/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5D159026-5048-B358-E864-401B9192E7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178384" y="3779592"/>
            <a:ext cx="7835230" cy="14219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5 blockade, a novel immune checkpoint inhibitor, enhances T cell anti-tumour immunity and delays tumour growth in mice harbouring poorly immunogenic 4T1 breast tumour </a:t>
            </a:r>
            <a:r>
              <a:rPr lang="en-CA" sz="2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omograft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774504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571F63-9922-EDB6-3E31-81D6FA7A7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b="1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1</a:t>
            </a:r>
            <a:endParaRPr lang="en-CA" dirty="0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BACE60FB-9935-1736-2921-80BA794394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8857" y="315912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43956BE-2648-3AD1-E5CA-FC8F67678F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2276871"/>
              </p:ext>
            </p:extLst>
          </p:nvPr>
        </p:nvGraphicFramePr>
        <p:xfrm>
          <a:off x="4502150" y="1517650"/>
          <a:ext cx="7046913" cy="4429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046415" imgH="4429174" progId="Prism10.Document">
                  <p:embed/>
                </p:oleObj>
              </mc:Choice>
              <mc:Fallback>
                <p:oleObj name="Prism 10" r:id="rId2" imgW="7046415" imgH="442917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02150" y="1517650"/>
                        <a:ext cx="7046913" cy="4429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Subtitle 4">
            <a:extLst>
              <a:ext uri="{FF2B5EF4-FFF2-40B4-BE49-F238E27FC236}">
                <a16:creationId xmlns:a16="http://schemas.microsoft.com/office/drawing/2014/main" id="{D5B131B5-9AF2-5963-E41E-DF0A54FBE221}"/>
              </a:ext>
            </a:extLst>
          </p:cNvPr>
          <p:cNvSpPr txBox="1">
            <a:spLocks/>
          </p:cNvSpPr>
          <p:nvPr/>
        </p:nvSpPr>
        <p:spPr>
          <a:xfrm>
            <a:off x="361756" y="2078038"/>
            <a:ext cx="6074099" cy="663771"/>
          </a:xfrm>
          <a:prstGeom prst="rect">
            <a:avLst/>
          </a:prstGeom>
        </p:spPr>
        <p:txBody>
          <a:bodyPr vert="horz" wrap="none" lIns="91440" tIns="45720" rIns="91440" bIns="45720" rtlCol="0">
            <a:sp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CA" sz="1600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1: Body weight of mice after treatment with</a:t>
            </a:r>
          </a:p>
          <a:p>
            <a:pPr marL="0" indent="0">
              <a:buNone/>
            </a:pPr>
            <a:r>
              <a:rPr lang="en-CA" sz="1600" dirty="0">
                <a:latin typeface="Arial" panose="020B0604020202020204" pitchFamily="34" charset="0"/>
                <a:ea typeface="Calibri" panose="020F0502020204030204" pitchFamily="34" charset="0"/>
              </a:rPr>
              <a:t> isotype control MAb and </a:t>
            </a:r>
            <a:r>
              <a:rPr lang="en-CA" sz="1600">
                <a:latin typeface="Arial" panose="020B0604020202020204" pitchFamily="34" charset="0"/>
                <a:ea typeface="Calibri" panose="020F0502020204030204" pitchFamily="34" charset="0"/>
              </a:rPr>
              <a:t>anti-CD5 MAb</a:t>
            </a:r>
            <a:r>
              <a:rPr lang="en-CA" sz="16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1751705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51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10</vt:lpstr>
      <vt:lpstr>Supplementary figure </vt:lpstr>
      <vt:lpstr>Supplementary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1. </dc:title>
  <dc:creator>Faizah Alotaibi</dc:creator>
  <cp:lastModifiedBy>Faizah Alotaibi</cp:lastModifiedBy>
  <cp:revision>5</cp:revision>
  <dcterms:created xsi:type="dcterms:W3CDTF">2023-08-25T08:54:21Z</dcterms:created>
  <dcterms:modified xsi:type="dcterms:W3CDTF">2024-02-21T04:46:31Z</dcterms:modified>
</cp:coreProperties>
</file>